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3" r:id="rId3"/>
    <p:sldId id="258" r:id="rId4"/>
    <p:sldId id="264" r:id="rId5"/>
    <p:sldId id="259" r:id="rId6"/>
    <p:sldId id="265" r:id="rId7"/>
    <p:sldId id="260" r:id="rId8"/>
    <p:sldId id="266" r:id="rId9"/>
    <p:sldId id="261" r:id="rId10"/>
    <p:sldId id="267" r:id="rId11"/>
    <p:sldId id="262" r:id="rId12"/>
    <p:sldId id="268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0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1.xlsx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2.xlsx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C1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15283</c:v>
                </c:pt>
                <c:pt idx="1">
                  <c:v>0.36348000000000003</c:v>
                </c:pt>
                <c:pt idx="2">
                  <c:v>0.33503333333333335</c:v>
                </c:pt>
                <c:pt idx="3">
                  <c:v>0.29109333333333332</c:v>
                </c:pt>
                <c:pt idx="4">
                  <c:v>0.30462000000000006</c:v>
                </c:pt>
                <c:pt idx="5">
                  <c:v>0.40707999999999994</c:v>
                </c:pt>
                <c:pt idx="6">
                  <c:v>0.57458333333333333</c:v>
                </c:pt>
                <c:pt idx="7">
                  <c:v>0.50172666666666677</c:v>
                </c:pt>
                <c:pt idx="8">
                  <c:v>0.39697333333333334</c:v>
                </c:pt>
                <c:pt idx="9">
                  <c:v>1.5543333333333334E-2</c:v>
                </c:pt>
                <c:pt idx="10">
                  <c:v>3.9373333333333337E-2</c:v>
                </c:pt>
                <c:pt idx="11">
                  <c:v>0.12150000000000001</c:v>
                </c:pt>
                <c:pt idx="12">
                  <c:v>0.13009666666666667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6747000000000005E-2</c:v>
                </c:pt>
                <c:pt idx="1">
                  <c:v>0.14261666666666667</c:v>
                </c:pt>
                <c:pt idx="2">
                  <c:v>0.11947999999999999</c:v>
                </c:pt>
                <c:pt idx="3">
                  <c:v>0.19419666666666668</c:v>
                </c:pt>
                <c:pt idx="4">
                  <c:v>0.19597333333333333</c:v>
                </c:pt>
                <c:pt idx="5">
                  <c:v>0.13023666666666667</c:v>
                </c:pt>
                <c:pt idx="6">
                  <c:v>9.1169999999999987E-2</c:v>
                </c:pt>
                <c:pt idx="7">
                  <c:v>9.5479999999999995E-2</c:v>
                </c:pt>
                <c:pt idx="8">
                  <c:v>8.4413333333333326E-2</c:v>
                </c:pt>
                <c:pt idx="9">
                  <c:v>6.273333333333333E-3</c:v>
                </c:pt>
                <c:pt idx="10">
                  <c:v>4.3650000000000001E-2</c:v>
                </c:pt>
                <c:pt idx="11">
                  <c:v>0.25798333333333334</c:v>
                </c:pt>
                <c:pt idx="12">
                  <c:v>8.0383333333333334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52547</c:v>
                </c:pt>
                <c:pt idx="1">
                  <c:v>0.27883999999999998</c:v>
                </c:pt>
                <c:pt idx="2">
                  <c:v>0.26378666666666667</c:v>
                </c:pt>
                <c:pt idx="3">
                  <c:v>0.19529333333333332</c:v>
                </c:pt>
                <c:pt idx="4">
                  <c:v>0.18931666666666666</c:v>
                </c:pt>
                <c:pt idx="5">
                  <c:v>0.19478666666666666</c:v>
                </c:pt>
                <c:pt idx="6">
                  <c:v>0.18951999999999999</c:v>
                </c:pt>
                <c:pt idx="7">
                  <c:v>0.19015000000000001</c:v>
                </c:pt>
                <c:pt idx="8">
                  <c:v>0.18755999999999998</c:v>
                </c:pt>
                <c:pt idx="9">
                  <c:v>0.45587333333333335</c:v>
                </c:pt>
                <c:pt idx="10">
                  <c:v>0.47024333333333335</c:v>
                </c:pt>
                <c:pt idx="11">
                  <c:v>0.40738333333333338</c:v>
                </c:pt>
                <c:pt idx="12">
                  <c:v>0.42236000000000001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4542299999999998</c:v>
                </c:pt>
                <c:pt idx="1">
                  <c:v>0.21505666666666667</c:v>
                </c:pt>
                <c:pt idx="2">
                  <c:v>0.28170000000000001</c:v>
                </c:pt>
                <c:pt idx="3">
                  <c:v>0.31941666666666668</c:v>
                </c:pt>
                <c:pt idx="4">
                  <c:v>0.31008999999999998</c:v>
                </c:pt>
                <c:pt idx="5">
                  <c:v>0.26790000000000003</c:v>
                </c:pt>
                <c:pt idx="6">
                  <c:v>0.14472666666666667</c:v>
                </c:pt>
                <c:pt idx="7">
                  <c:v>0.21264333333333332</c:v>
                </c:pt>
                <c:pt idx="8">
                  <c:v>0.33105999999999997</c:v>
                </c:pt>
                <c:pt idx="9">
                  <c:v>0.52231000000000005</c:v>
                </c:pt>
                <c:pt idx="10">
                  <c:v>0.44673999999999997</c:v>
                </c:pt>
                <c:pt idx="11">
                  <c:v>0.21312999999999996</c:v>
                </c:pt>
                <c:pt idx="12">
                  <c:v>0.36715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85337104"/>
        <c:axId val="185336544"/>
      </c:barChart>
      <c:valAx>
        <c:axId val="185336544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5’ Base</a:t>
                </a:r>
                <a:r>
                  <a:rPr lang="en-US" baseline="0" dirty="0" smtClean="0"/>
                  <a:t> dominance </a:t>
                </a: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337104"/>
        <c:crosses val="autoZero"/>
        <c:crossBetween val="between"/>
      </c:valAx>
      <c:catAx>
        <c:axId val="18533710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cleotide size distribution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33654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1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7078666666666664</c:v>
                </c:pt>
                <c:pt idx="1">
                  <c:v>0.38304333333333335</c:v>
                </c:pt>
                <c:pt idx="2">
                  <c:v>0.3553566666666666</c:v>
                </c:pt>
                <c:pt idx="3">
                  <c:v>0.29903999999999997</c:v>
                </c:pt>
                <c:pt idx="4">
                  <c:v>0.28830333333333336</c:v>
                </c:pt>
                <c:pt idx="5">
                  <c:v>0.41482666666666668</c:v>
                </c:pt>
                <c:pt idx="6">
                  <c:v>0.57815666666666676</c:v>
                </c:pt>
                <c:pt idx="7">
                  <c:v>0.50001666666666666</c:v>
                </c:pt>
                <c:pt idx="8">
                  <c:v>0.40076333333333336</c:v>
                </c:pt>
                <c:pt idx="9">
                  <c:v>1.3806666666666667E-2</c:v>
                </c:pt>
                <c:pt idx="10">
                  <c:v>3.4179999999999995E-2</c:v>
                </c:pt>
                <c:pt idx="11">
                  <c:v>0.14595666666666668</c:v>
                </c:pt>
                <c:pt idx="12">
                  <c:v>0.11740666666666666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6.8800000000000014E-2</c:v>
                </c:pt>
                <c:pt idx="1">
                  <c:v>0.12071999999999999</c:v>
                </c:pt>
                <c:pt idx="2">
                  <c:v>0.11344333333333334</c:v>
                </c:pt>
                <c:pt idx="3">
                  <c:v>0.1966</c:v>
                </c:pt>
                <c:pt idx="4">
                  <c:v>0.19580333333333333</c:v>
                </c:pt>
                <c:pt idx="5">
                  <c:v>0.12783666666666668</c:v>
                </c:pt>
                <c:pt idx="6">
                  <c:v>9.1350000000000001E-2</c:v>
                </c:pt>
                <c:pt idx="7">
                  <c:v>0.10087</c:v>
                </c:pt>
                <c:pt idx="8">
                  <c:v>8.6053333333333329E-2</c:v>
                </c:pt>
                <c:pt idx="9">
                  <c:v>6.4500000000000009E-3</c:v>
                </c:pt>
                <c:pt idx="10">
                  <c:v>4.0926666666666667E-2</c:v>
                </c:pt>
                <c:pt idx="11">
                  <c:v>0.18472</c:v>
                </c:pt>
                <c:pt idx="12">
                  <c:v>6.4759999999999998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8185333333333338</c:v>
                </c:pt>
                <c:pt idx="1">
                  <c:v>0.31231666666666663</c:v>
                </c:pt>
                <c:pt idx="2">
                  <c:v>0.27960999999999997</c:v>
                </c:pt>
                <c:pt idx="3">
                  <c:v>0.19244666666666665</c:v>
                </c:pt>
                <c:pt idx="4">
                  <c:v>0.18681999999999999</c:v>
                </c:pt>
                <c:pt idx="5">
                  <c:v>0.19585666666666665</c:v>
                </c:pt>
                <c:pt idx="6">
                  <c:v>0.18794999999999998</c:v>
                </c:pt>
                <c:pt idx="7">
                  <c:v>0.18330333333333335</c:v>
                </c:pt>
                <c:pt idx="8">
                  <c:v>0.16504333333333335</c:v>
                </c:pt>
                <c:pt idx="9">
                  <c:v>0.44976333333333329</c:v>
                </c:pt>
                <c:pt idx="10">
                  <c:v>0.46451666666666663</c:v>
                </c:pt>
                <c:pt idx="11">
                  <c:v>0.35051000000000004</c:v>
                </c:pt>
                <c:pt idx="12">
                  <c:v>0.42768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7856000000000001</c:v>
                </c:pt>
                <c:pt idx="1">
                  <c:v>0.18392666666666668</c:v>
                </c:pt>
                <c:pt idx="2">
                  <c:v>0.25159333333333334</c:v>
                </c:pt>
                <c:pt idx="3">
                  <c:v>0.31190999999999997</c:v>
                </c:pt>
                <c:pt idx="4">
                  <c:v>0.32907333333333333</c:v>
                </c:pt>
                <c:pt idx="5">
                  <c:v>0.26147999999999999</c:v>
                </c:pt>
                <c:pt idx="6">
                  <c:v>0.14254</c:v>
                </c:pt>
                <c:pt idx="7">
                  <c:v>0.21580999999999997</c:v>
                </c:pt>
                <c:pt idx="8">
                  <c:v>0.3481433333333333</c:v>
                </c:pt>
                <c:pt idx="9">
                  <c:v>0.52997666666666665</c:v>
                </c:pt>
                <c:pt idx="10">
                  <c:v>0.46038000000000001</c:v>
                </c:pt>
                <c:pt idx="11">
                  <c:v>0.31881333333333334</c:v>
                </c:pt>
                <c:pt idx="12">
                  <c:v>0.390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377584"/>
        <c:axId val="193379824"/>
      </c:barChart>
      <c:valAx>
        <c:axId val="193379824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77584"/>
        <c:crosses val="autoZero"/>
        <c:crossBetween val="between"/>
      </c:valAx>
      <c:catAx>
        <c:axId val="19337758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7982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C4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7635333333333333</c:v>
                </c:pt>
                <c:pt idx="1">
                  <c:v>0.38249666666666665</c:v>
                </c:pt>
                <c:pt idx="2">
                  <c:v>0.34677666666666668</c:v>
                </c:pt>
                <c:pt idx="3">
                  <c:v>0.29809000000000002</c:v>
                </c:pt>
                <c:pt idx="4">
                  <c:v>0.30244000000000004</c:v>
                </c:pt>
                <c:pt idx="5">
                  <c:v>0.41417333333333328</c:v>
                </c:pt>
                <c:pt idx="6">
                  <c:v>0.56951000000000007</c:v>
                </c:pt>
                <c:pt idx="7">
                  <c:v>0.49704666666666664</c:v>
                </c:pt>
                <c:pt idx="8">
                  <c:v>0.41070666666666672</c:v>
                </c:pt>
                <c:pt idx="9">
                  <c:v>1.4536666666666665E-2</c:v>
                </c:pt>
                <c:pt idx="10">
                  <c:v>3.6646666666666661E-2</c:v>
                </c:pt>
                <c:pt idx="11">
                  <c:v>0.15337999999999999</c:v>
                </c:pt>
                <c:pt idx="12">
                  <c:v>0.12280666666666666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7.342333333333334E-2</c:v>
                </c:pt>
                <c:pt idx="1">
                  <c:v>0.1245</c:v>
                </c:pt>
                <c:pt idx="2">
                  <c:v>0.11402333333333332</c:v>
                </c:pt>
                <c:pt idx="3">
                  <c:v>0.18456666666666668</c:v>
                </c:pt>
                <c:pt idx="4">
                  <c:v>0.19232000000000002</c:v>
                </c:pt>
                <c:pt idx="5">
                  <c:v>0.12756666666666666</c:v>
                </c:pt>
                <c:pt idx="6">
                  <c:v>9.2793333333333325E-2</c:v>
                </c:pt>
                <c:pt idx="7">
                  <c:v>0.10099999999999999</c:v>
                </c:pt>
                <c:pt idx="8">
                  <c:v>7.9789999999999986E-2</c:v>
                </c:pt>
                <c:pt idx="9">
                  <c:v>6.0899999999999991E-3</c:v>
                </c:pt>
                <c:pt idx="10">
                  <c:v>4.5449999999999997E-2</c:v>
                </c:pt>
                <c:pt idx="11">
                  <c:v>0.19393666666666667</c:v>
                </c:pt>
                <c:pt idx="12">
                  <c:v>7.4313333333333342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752166666666667</c:v>
                </c:pt>
                <c:pt idx="1">
                  <c:v>0.30438000000000004</c:v>
                </c:pt>
                <c:pt idx="2">
                  <c:v>0.26848333333333335</c:v>
                </c:pt>
                <c:pt idx="3">
                  <c:v>0.19191333333333335</c:v>
                </c:pt>
                <c:pt idx="4">
                  <c:v>0.18220999999999998</c:v>
                </c:pt>
                <c:pt idx="5">
                  <c:v>0.18884999999999999</c:v>
                </c:pt>
                <c:pt idx="6">
                  <c:v>0.19064</c:v>
                </c:pt>
                <c:pt idx="7">
                  <c:v>0.18734999999999999</c:v>
                </c:pt>
                <c:pt idx="8">
                  <c:v>0.19077666666666668</c:v>
                </c:pt>
                <c:pt idx="9">
                  <c:v>0.45052666666666669</c:v>
                </c:pt>
                <c:pt idx="10">
                  <c:v>0.46379333333333334</c:v>
                </c:pt>
                <c:pt idx="11">
                  <c:v>0.36194333333333334</c:v>
                </c:pt>
                <c:pt idx="12">
                  <c:v>0.43325999999999998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7501000000000001</c:v>
                </c:pt>
                <c:pt idx="1">
                  <c:v>0.18862333333333334</c:v>
                </c:pt>
                <c:pt idx="2">
                  <c:v>0.27071666666666666</c:v>
                </c:pt>
                <c:pt idx="3">
                  <c:v>0.3254266666666667</c:v>
                </c:pt>
                <c:pt idx="4">
                  <c:v>0.32303333333333334</c:v>
                </c:pt>
                <c:pt idx="5">
                  <c:v>0.26940333333333333</c:v>
                </c:pt>
                <c:pt idx="6">
                  <c:v>0.14705666666666667</c:v>
                </c:pt>
                <c:pt idx="7">
                  <c:v>0.21460333333333334</c:v>
                </c:pt>
                <c:pt idx="8">
                  <c:v>0.31872666666666666</c:v>
                </c:pt>
                <c:pt idx="9">
                  <c:v>0.52884666666666658</c:v>
                </c:pt>
                <c:pt idx="10">
                  <c:v>0.45411333333333337</c:v>
                </c:pt>
                <c:pt idx="11">
                  <c:v>0.29074</c:v>
                </c:pt>
                <c:pt idx="12">
                  <c:v>0.369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2602288"/>
        <c:axId val="192601728"/>
      </c:barChart>
      <c:valAx>
        <c:axId val="192601728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602288"/>
        <c:crosses val="autoZero"/>
        <c:crossBetween val="between"/>
      </c:valAx>
      <c:catAx>
        <c:axId val="1926022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60172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T4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9005666700000001</c:v>
                </c:pt>
                <c:pt idx="1">
                  <c:v>0.37808999999999998</c:v>
                </c:pt>
                <c:pt idx="2">
                  <c:v>0.34871999999999997</c:v>
                </c:pt>
                <c:pt idx="3">
                  <c:v>0.29880666700000003</c:v>
                </c:pt>
                <c:pt idx="4">
                  <c:v>0.29560666699999999</c:v>
                </c:pt>
                <c:pt idx="5">
                  <c:v>0.4124133333333333</c:v>
                </c:pt>
                <c:pt idx="6">
                  <c:v>0.57404999999999995</c:v>
                </c:pt>
                <c:pt idx="7">
                  <c:v>0.49984666700000002</c:v>
                </c:pt>
                <c:pt idx="8">
                  <c:v>0.40953000000000001</c:v>
                </c:pt>
                <c:pt idx="9">
                  <c:v>1.4966666666666668E-2</c:v>
                </c:pt>
                <c:pt idx="10">
                  <c:v>4.2959999999999998E-2</c:v>
                </c:pt>
                <c:pt idx="11">
                  <c:v>0.14871333333333334</c:v>
                </c:pt>
                <c:pt idx="12">
                  <c:v>0.12874333333333335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7.8346666999999995E-2</c:v>
                </c:pt>
                <c:pt idx="1">
                  <c:v>0.13195999999999999</c:v>
                </c:pt>
                <c:pt idx="2">
                  <c:v>0.12861</c:v>
                </c:pt>
                <c:pt idx="3">
                  <c:v>0.196816667</c:v>
                </c:pt>
                <c:pt idx="4">
                  <c:v>0.199743333</c:v>
                </c:pt>
                <c:pt idx="5">
                  <c:v>0.12867999999999999</c:v>
                </c:pt>
                <c:pt idx="6">
                  <c:v>9.2353332999999996E-2</c:v>
                </c:pt>
                <c:pt idx="7">
                  <c:v>0.10084</c:v>
                </c:pt>
                <c:pt idx="8">
                  <c:v>8.3826666999999994E-2</c:v>
                </c:pt>
                <c:pt idx="9">
                  <c:v>6.3200000000000001E-3</c:v>
                </c:pt>
                <c:pt idx="10">
                  <c:v>4.9826666666666665E-2</c:v>
                </c:pt>
                <c:pt idx="11">
                  <c:v>0.21866333333333332</c:v>
                </c:pt>
                <c:pt idx="12">
                  <c:v>7.8753333333333342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6447666699999998</c:v>
                </c:pt>
                <c:pt idx="1">
                  <c:v>0.29038000000000003</c:v>
                </c:pt>
                <c:pt idx="2">
                  <c:v>0.25352333300000002</c:v>
                </c:pt>
                <c:pt idx="3">
                  <c:v>0.18900666699999999</c:v>
                </c:pt>
                <c:pt idx="4">
                  <c:v>0.17853333299999999</c:v>
                </c:pt>
                <c:pt idx="5">
                  <c:v>0.18783333333333332</c:v>
                </c:pt>
                <c:pt idx="6">
                  <c:v>0.18680666700000001</c:v>
                </c:pt>
                <c:pt idx="7">
                  <c:v>0.18278333299999999</c:v>
                </c:pt>
                <c:pt idx="8">
                  <c:v>0.186356667</c:v>
                </c:pt>
                <c:pt idx="9">
                  <c:v>0.45304666666666665</c:v>
                </c:pt>
                <c:pt idx="10">
                  <c:v>0.46717999999999993</c:v>
                </c:pt>
                <c:pt idx="11">
                  <c:v>0.3687266666666667</c:v>
                </c:pt>
                <c:pt idx="12">
                  <c:v>0.42573666666666665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6712</c:v>
                </c:pt>
                <c:pt idx="1">
                  <c:v>0.19957</c:v>
                </c:pt>
                <c:pt idx="2">
                  <c:v>0.26914333299999998</c:v>
                </c:pt>
                <c:pt idx="3">
                  <c:v>0.31536999999999998</c:v>
                </c:pt>
                <c:pt idx="4">
                  <c:v>0.32612000000000002</c:v>
                </c:pt>
                <c:pt idx="5">
                  <c:v>0.27107333333333333</c:v>
                </c:pt>
                <c:pt idx="6">
                  <c:v>0.14679</c:v>
                </c:pt>
                <c:pt idx="7">
                  <c:v>0.21653333299999999</c:v>
                </c:pt>
                <c:pt idx="8">
                  <c:v>0.32028666700000002</c:v>
                </c:pt>
                <c:pt idx="9">
                  <c:v>0.52567333333333333</c:v>
                </c:pt>
                <c:pt idx="10">
                  <c:v>0.44002666666666662</c:v>
                </c:pt>
                <c:pt idx="11">
                  <c:v>0.26389333333333331</c:v>
                </c:pt>
                <c:pt idx="12">
                  <c:v>0.366766666666666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1891616"/>
        <c:axId val="241891056"/>
      </c:barChart>
      <c:valAx>
        <c:axId val="24189105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91616"/>
        <c:crosses val="autoZero"/>
        <c:crossBetween val="between"/>
      </c:valAx>
      <c:catAx>
        <c:axId val="2418916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910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1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0253999999999997</c:v>
                </c:pt>
                <c:pt idx="1">
                  <c:v>0.36750666666666665</c:v>
                </c:pt>
                <c:pt idx="2">
                  <c:v>0.33515999999999996</c:v>
                </c:pt>
                <c:pt idx="3">
                  <c:v>0.29436666666666667</c:v>
                </c:pt>
                <c:pt idx="4">
                  <c:v>0.30569333333333337</c:v>
                </c:pt>
                <c:pt idx="5">
                  <c:v>0.41243000000000002</c:v>
                </c:pt>
                <c:pt idx="6">
                  <c:v>0.58209999999999995</c:v>
                </c:pt>
                <c:pt idx="7">
                  <c:v>0.50875999999999999</c:v>
                </c:pt>
                <c:pt idx="8">
                  <c:v>0.4050766666666667</c:v>
                </c:pt>
                <c:pt idx="9">
                  <c:v>1.4039999999999999E-2</c:v>
                </c:pt>
                <c:pt idx="10">
                  <c:v>3.1023333333333337E-2</c:v>
                </c:pt>
                <c:pt idx="11">
                  <c:v>0.13752333333333333</c:v>
                </c:pt>
                <c:pt idx="12">
                  <c:v>0.11965333333333333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6426666666666666E-2</c:v>
                </c:pt>
                <c:pt idx="1">
                  <c:v>0.13712333333333335</c:v>
                </c:pt>
                <c:pt idx="2">
                  <c:v>0.11620000000000001</c:v>
                </c:pt>
                <c:pt idx="3">
                  <c:v>0.1867466666666667</c:v>
                </c:pt>
                <c:pt idx="4">
                  <c:v>0.19276333333333331</c:v>
                </c:pt>
                <c:pt idx="5">
                  <c:v>0.12888999999999998</c:v>
                </c:pt>
                <c:pt idx="6">
                  <c:v>8.9956666666666671E-2</c:v>
                </c:pt>
                <c:pt idx="7">
                  <c:v>9.4949999999999993E-2</c:v>
                </c:pt>
                <c:pt idx="8">
                  <c:v>8.1293333333333329E-2</c:v>
                </c:pt>
                <c:pt idx="9">
                  <c:v>6.1766666666666671E-3</c:v>
                </c:pt>
                <c:pt idx="10">
                  <c:v>4.1166666666666664E-2</c:v>
                </c:pt>
                <c:pt idx="11">
                  <c:v>0.20374666666666666</c:v>
                </c:pt>
                <c:pt idx="12">
                  <c:v>7.4510000000000007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6016666666666669</c:v>
                </c:pt>
                <c:pt idx="1">
                  <c:v>0.28147666666666665</c:v>
                </c:pt>
                <c:pt idx="2">
                  <c:v>0.27046999999999999</c:v>
                </c:pt>
                <c:pt idx="3">
                  <c:v>0.19656333333333334</c:v>
                </c:pt>
                <c:pt idx="4">
                  <c:v>0.19017666666666666</c:v>
                </c:pt>
                <c:pt idx="5">
                  <c:v>0.18893333333333331</c:v>
                </c:pt>
                <c:pt idx="6">
                  <c:v>0.18541333333333335</c:v>
                </c:pt>
                <c:pt idx="7">
                  <c:v>0.18457333333333334</c:v>
                </c:pt>
                <c:pt idx="8">
                  <c:v>0.17572333333333334</c:v>
                </c:pt>
                <c:pt idx="9">
                  <c:v>0.45821666666666666</c:v>
                </c:pt>
                <c:pt idx="10">
                  <c:v>0.47450999999999999</c:v>
                </c:pt>
                <c:pt idx="11">
                  <c:v>0.37778</c:v>
                </c:pt>
                <c:pt idx="12">
                  <c:v>0.43198000000000003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5087000000000002</c:v>
                </c:pt>
                <c:pt idx="1">
                  <c:v>0.21389666666666665</c:v>
                </c:pt>
                <c:pt idx="2">
                  <c:v>0.27817000000000003</c:v>
                </c:pt>
                <c:pt idx="3">
                  <c:v>0.32232</c:v>
                </c:pt>
                <c:pt idx="4">
                  <c:v>0.31136666666666662</c:v>
                </c:pt>
                <c:pt idx="5">
                  <c:v>0.26974333333333333</c:v>
                </c:pt>
                <c:pt idx="6">
                  <c:v>0.14253333333333332</c:v>
                </c:pt>
                <c:pt idx="7">
                  <c:v>0.21171333333333334</c:v>
                </c:pt>
                <c:pt idx="8">
                  <c:v>0.33790666666666663</c:v>
                </c:pt>
                <c:pt idx="9">
                  <c:v>0.52156666666666673</c:v>
                </c:pt>
                <c:pt idx="10">
                  <c:v>0.45329666666666668</c:v>
                </c:pt>
                <c:pt idx="11">
                  <c:v>0.28094666666666668</c:v>
                </c:pt>
                <c:pt idx="12">
                  <c:v>0.373856666666666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2867552"/>
        <c:axId val="192868112"/>
      </c:barChart>
      <c:valAx>
        <c:axId val="192868112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5’ Base</a:t>
                </a:r>
                <a:r>
                  <a:rPr lang="en-US" baseline="0" dirty="0" smtClean="0"/>
                  <a:t> dominance </a:t>
                </a:r>
                <a:r>
                  <a:rPr lang="en-US" dirty="0" smtClean="0"/>
                  <a:t>Percentage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867552"/>
        <c:crosses val="autoZero"/>
        <c:crossBetween val="between"/>
      </c:valAx>
      <c:catAx>
        <c:axId val="1928675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97" b="0" i="0" u="none" strike="noStrike" kern="1200" cap="all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Nucleotide size distribution</a:t>
                </a:r>
                <a:endParaRPr 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97" b="0" i="0" u="none" strike="noStrike" kern="1200" cap="all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286811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C4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3140666666666665</c:v>
                </c:pt>
                <c:pt idx="1">
                  <c:v>0.35985333333333336</c:v>
                </c:pt>
                <c:pt idx="2">
                  <c:v>0.32683333333333331</c:v>
                </c:pt>
                <c:pt idx="3">
                  <c:v>0.29360333333333338</c:v>
                </c:pt>
                <c:pt idx="4">
                  <c:v>0.31136999999999998</c:v>
                </c:pt>
                <c:pt idx="5">
                  <c:v>0.40365000000000001</c:v>
                </c:pt>
                <c:pt idx="6">
                  <c:v>0.56049666666666664</c:v>
                </c:pt>
                <c:pt idx="7">
                  <c:v>0.49525000000000002</c:v>
                </c:pt>
                <c:pt idx="8">
                  <c:v>0.39308000000000004</c:v>
                </c:pt>
                <c:pt idx="9">
                  <c:v>1.5556666666666665E-2</c:v>
                </c:pt>
                <c:pt idx="10">
                  <c:v>3.322E-2</c:v>
                </c:pt>
                <c:pt idx="11">
                  <c:v>0.14995</c:v>
                </c:pt>
                <c:pt idx="12">
                  <c:v>0.14156000000000002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8069999999999991E-2</c:v>
                </c:pt>
                <c:pt idx="1">
                  <c:v>0.14233000000000001</c:v>
                </c:pt>
                <c:pt idx="2">
                  <c:v>0.11724666666666667</c:v>
                </c:pt>
                <c:pt idx="3">
                  <c:v>0.18652000000000002</c:v>
                </c:pt>
                <c:pt idx="4">
                  <c:v>0.18761000000000003</c:v>
                </c:pt>
                <c:pt idx="5">
                  <c:v>0.13047333333333333</c:v>
                </c:pt>
                <c:pt idx="6">
                  <c:v>9.4229999999999994E-2</c:v>
                </c:pt>
                <c:pt idx="7">
                  <c:v>9.6696666666666653E-2</c:v>
                </c:pt>
                <c:pt idx="8">
                  <c:v>7.9773333333333349E-2</c:v>
                </c:pt>
                <c:pt idx="9">
                  <c:v>5.749999999999999E-3</c:v>
                </c:pt>
                <c:pt idx="10">
                  <c:v>3.4416666666666665E-2</c:v>
                </c:pt>
                <c:pt idx="11">
                  <c:v>0.19516999999999998</c:v>
                </c:pt>
                <c:pt idx="12">
                  <c:v>8.7643333333333337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3939999999999998</c:v>
                </c:pt>
                <c:pt idx="1">
                  <c:v>0.26305333333333336</c:v>
                </c:pt>
                <c:pt idx="2">
                  <c:v>0.25336666666666668</c:v>
                </c:pt>
                <c:pt idx="3">
                  <c:v>0.19752999999999998</c:v>
                </c:pt>
                <c:pt idx="4">
                  <c:v>0.19259000000000001</c:v>
                </c:pt>
                <c:pt idx="5">
                  <c:v>0.19104666666666667</c:v>
                </c:pt>
                <c:pt idx="6">
                  <c:v>0.19883999999999999</c:v>
                </c:pt>
                <c:pt idx="7">
                  <c:v>0.19876333333333332</c:v>
                </c:pt>
                <c:pt idx="8">
                  <c:v>0.21905333333333332</c:v>
                </c:pt>
                <c:pt idx="9">
                  <c:v>0.46744666666666662</c:v>
                </c:pt>
                <c:pt idx="10">
                  <c:v>0.47872666666666669</c:v>
                </c:pt>
                <c:pt idx="11">
                  <c:v>0.38933999999999996</c:v>
                </c:pt>
                <c:pt idx="12">
                  <c:v>0.44152333333333332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112000000000003</c:v>
                </c:pt>
                <c:pt idx="1">
                  <c:v>0.23476666666666668</c:v>
                </c:pt>
                <c:pt idx="2">
                  <c:v>0.3025533333333334</c:v>
                </c:pt>
                <c:pt idx="3">
                  <c:v>0.32234666666666667</c:v>
                </c:pt>
                <c:pt idx="4">
                  <c:v>0.30843333333333334</c:v>
                </c:pt>
                <c:pt idx="5">
                  <c:v>0.27482999999999996</c:v>
                </c:pt>
                <c:pt idx="6">
                  <c:v>0.14643666666666666</c:v>
                </c:pt>
                <c:pt idx="7">
                  <c:v>0.20928999999999998</c:v>
                </c:pt>
                <c:pt idx="8">
                  <c:v>0.30809333333333333</c:v>
                </c:pt>
                <c:pt idx="9">
                  <c:v>0.51124666666666663</c:v>
                </c:pt>
                <c:pt idx="10">
                  <c:v>0.45363666666666669</c:v>
                </c:pt>
                <c:pt idx="11">
                  <c:v>0.2655433333333333</c:v>
                </c:pt>
                <c:pt idx="12">
                  <c:v>0.329269999999999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0823008"/>
        <c:axId val="190822448"/>
      </c:barChart>
      <c:valAx>
        <c:axId val="190822448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823008"/>
        <c:crosses val="autoZero"/>
        <c:crossBetween val="between"/>
      </c:valAx>
      <c:catAx>
        <c:axId val="1908230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082244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JT4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1923999999999999</c:v>
                </c:pt>
                <c:pt idx="1">
                  <c:v>0.35978333333333334</c:v>
                </c:pt>
                <c:pt idx="2">
                  <c:v>0.33193333333333336</c:v>
                </c:pt>
                <c:pt idx="3">
                  <c:v>0.29531666666666667</c:v>
                </c:pt>
                <c:pt idx="4">
                  <c:v>0.30074333333333336</c:v>
                </c:pt>
                <c:pt idx="5">
                  <c:v>0.40872999999999998</c:v>
                </c:pt>
                <c:pt idx="6">
                  <c:v>0.57255</c:v>
                </c:pt>
                <c:pt idx="7">
                  <c:v>0.49820666666666669</c:v>
                </c:pt>
                <c:pt idx="8">
                  <c:v>0.3994866666666666</c:v>
                </c:pt>
                <c:pt idx="9">
                  <c:v>1.4619999999999999E-2</c:v>
                </c:pt>
                <c:pt idx="10">
                  <c:v>3.6016666666666669E-2</c:v>
                </c:pt>
                <c:pt idx="11">
                  <c:v>0.13003333333333333</c:v>
                </c:pt>
                <c:pt idx="12">
                  <c:v>0.15159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4373333333333351E-2</c:v>
                </c:pt>
                <c:pt idx="1">
                  <c:v>0.14142666666666667</c:v>
                </c:pt>
                <c:pt idx="2">
                  <c:v>0.12123333333333335</c:v>
                </c:pt>
                <c:pt idx="3">
                  <c:v>0.19442333333333336</c:v>
                </c:pt>
                <c:pt idx="4">
                  <c:v>0.19161333333333333</c:v>
                </c:pt>
                <c:pt idx="5">
                  <c:v>0.12856666666666666</c:v>
                </c:pt>
                <c:pt idx="6">
                  <c:v>9.116666666666666E-2</c:v>
                </c:pt>
                <c:pt idx="7">
                  <c:v>9.7353333333333333E-2</c:v>
                </c:pt>
                <c:pt idx="8">
                  <c:v>7.7766666666666664E-2</c:v>
                </c:pt>
                <c:pt idx="9">
                  <c:v>6.4300000000000008E-3</c:v>
                </c:pt>
                <c:pt idx="10">
                  <c:v>3.8766666666666665E-2</c:v>
                </c:pt>
                <c:pt idx="11">
                  <c:v>0.22762333333333332</c:v>
                </c:pt>
                <c:pt idx="12">
                  <c:v>9.0006666666666665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4741</c:v>
                </c:pt>
                <c:pt idx="1">
                  <c:v>0.28165333333333331</c:v>
                </c:pt>
                <c:pt idx="2">
                  <c:v>0.26035333333333327</c:v>
                </c:pt>
                <c:pt idx="3">
                  <c:v>0.19245666666666664</c:v>
                </c:pt>
                <c:pt idx="4">
                  <c:v>0.19005333333333332</c:v>
                </c:pt>
                <c:pt idx="5">
                  <c:v>0.19096333333333329</c:v>
                </c:pt>
                <c:pt idx="6">
                  <c:v>0.19036333333333333</c:v>
                </c:pt>
                <c:pt idx="7">
                  <c:v>0.19036</c:v>
                </c:pt>
                <c:pt idx="8">
                  <c:v>0.18835000000000002</c:v>
                </c:pt>
                <c:pt idx="9">
                  <c:v>0.45779999999999998</c:v>
                </c:pt>
                <c:pt idx="10">
                  <c:v>0.48095666666666664</c:v>
                </c:pt>
                <c:pt idx="11">
                  <c:v>0.3955933333333333</c:v>
                </c:pt>
                <c:pt idx="12">
                  <c:v>0.4245666666666667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897333333333335</c:v>
                </c:pt>
                <c:pt idx="1">
                  <c:v>0.21713000000000002</c:v>
                </c:pt>
                <c:pt idx="2">
                  <c:v>0.28648333333333337</c:v>
                </c:pt>
                <c:pt idx="3">
                  <c:v>0.31780333333333327</c:v>
                </c:pt>
                <c:pt idx="4">
                  <c:v>0.31758999999999998</c:v>
                </c:pt>
                <c:pt idx="5">
                  <c:v>0.27174000000000004</c:v>
                </c:pt>
                <c:pt idx="6">
                  <c:v>0.14592000000000002</c:v>
                </c:pt>
                <c:pt idx="7">
                  <c:v>0.21407666666666669</c:v>
                </c:pt>
                <c:pt idx="8">
                  <c:v>0.33439666666666668</c:v>
                </c:pt>
                <c:pt idx="9">
                  <c:v>0.52114666666666665</c:v>
                </c:pt>
                <c:pt idx="10">
                  <c:v>0.44426000000000004</c:v>
                </c:pt>
                <c:pt idx="11">
                  <c:v>0.24675000000000002</c:v>
                </c:pt>
                <c:pt idx="12">
                  <c:v>0.333836666666666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37652608"/>
        <c:axId val="237652048"/>
      </c:barChart>
      <c:valAx>
        <c:axId val="237652048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652608"/>
        <c:crosses val="autoZero"/>
        <c:crossBetween val="between"/>
      </c:valAx>
      <c:catAx>
        <c:axId val="23765260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765204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C1</a:t>
            </a:r>
            <a:endParaRPr lang="en-US" dirty="0" smtClean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1063333333333334</c:v>
                </c:pt>
                <c:pt idx="1">
                  <c:v>0.36630000000000001</c:v>
                </c:pt>
                <c:pt idx="2">
                  <c:v>0.33843000000000001</c:v>
                </c:pt>
                <c:pt idx="3">
                  <c:v>0.29763333333333331</c:v>
                </c:pt>
                <c:pt idx="4">
                  <c:v>0.30064666666666667</c:v>
                </c:pt>
                <c:pt idx="5">
                  <c:v>0.40972666666666663</c:v>
                </c:pt>
                <c:pt idx="6">
                  <c:v>0.57006000000000001</c:v>
                </c:pt>
                <c:pt idx="7">
                  <c:v>0.49998666666666663</c:v>
                </c:pt>
                <c:pt idx="8">
                  <c:v>0.3992</c:v>
                </c:pt>
                <c:pt idx="9">
                  <c:v>1.7579999999999998E-2</c:v>
                </c:pt>
                <c:pt idx="10">
                  <c:v>4.0433333333333328E-2</c:v>
                </c:pt>
                <c:pt idx="11">
                  <c:v>0.14347666666666667</c:v>
                </c:pt>
                <c:pt idx="12">
                  <c:v>0.11809333333333333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4163333333333326E-2</c:v>
                </c:pt>
                <c:pt idx="1">
                  <c:v>0.13763</c:v>
                </c:pt>
                <c:pt idx="2">
                  <c:v>0.11649666666666665</c:v>
                </c:pt>
                <c:pt idx="3">
                  <c:v>0.18476333333333331</c:v>
                </c:pt>
                <c:pt idx="4">
                  <c:v>0.19022666666666668</c:v>
                </c:pt>
                <c:pt idx="5">
                  <c:v>0.12800666666666669</c:v>
                </c:pt>
                <c:pt idx="6">
                  <c:v>9.2760000000000009E-2</c:v>
                </c:pt>
                <c:pt idx="7">
                  <c:v>0.10015</c:v>
                </c:pt>
                <c:pt idx="8">
                  <c:v>9.2619999999999994E-2</c:v>
                </c:pt>
                <c:pt idx="9">
                  <c:v>7.423333333333333E-3</c:v>
                </c:pt>
                <c:pt idx="10">
                  <c:v>4.7966666666666664E-2</c:v>
                </c:pt>
                <c:pt idx="11">
                  <c:v>0.18598333333333331</c:v>
                </c:pt>
                <c:pt idx="12">
                  <c:v>6.8193333333333328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4993666666666662</c:v>
                </c:pt>
                <c:pt idx="1">
                  <c:v>0.28633333333333333</c:v>
                </c:pt>
                <c:pt idx="2">
                  <c:v>0.27988000000000002</c:v>
                </c:pt>
                <c:pt idx="3">
                  <c:v>0.19754666666666665</c:v>
                </c:pt>
                <c:pt idx="4">
                  <c:v>0.19088333333333332</c:v>
                </c:pt>
                <c:pt idx="5">
                  <c:v>0.19360333333333335</c:v>
                </c:pt>
                <c:pt idx="6">
                  <c:v>0.19203333333333336</c:v>
                </c:pt>
                <c:pt idx="7">
                  <c:v>0.18722333333333332</c:v>
                </c:pt>
                <c:pt idx="8">
                  <c:v>0.18314</c:v>
                </c:pt>
                <c:pt idx="9">
                  <c:v>0.45038666666666666</c:v>
                </c:pt>
                <c:pt idx="10">
                  <c:v>0.46334666666666663</c:v>
                </c:pt>
                <c:pt idx="11">
                  <c:v>0.36415999999999998</c:v>
                </c:pt>
                <c:pt idx="12">
                  <c:v>0.42947666666666667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5526333333333332</c:v>
                </c:pt>
                <c:pt idx="1">
                  <c:v>0.20973333333333333</c:v>
                </c:pt>
                <c:pt idx="2">
                  <c:v>0.26519666666666669</c:v>
                </c:pt>
                <c:pt idx="3">
                  <c:v>0.3200533333333333</c:v>
                </c:pt>
                <c:pt idx="4">
                  <c:v>0.31824333333333338</c:v>
                </c:pt>
                <c:pt idx="5">
                  <c:v>0.26866666666666666</c:v>
                </c:pt>
                <c:pt idx="6">
                  <c:v>0.14514666666666667</c:v>
                </c:pt>
                <c:pt idx="7">
                  <c:v>0.21264000000000002</c:v>
                </c:pt>
                <c:pt idx="8">
                  <c:v>0.32504</c:v>
                </c:pt>
                <c:pt idx="9">
                  <c:v>0.52460666666666678</c:v>
                </c:pt>
                <c:pt idx="10">
                  <c:v>0.44826000000000005</c:v>
                </c:pt>
                <c:pt idx="11">
                  <c:v>0.30637666666666669</c:v>
                </c:pt>
                <c:pt idx="12">
                  <c:v>0.384236666666666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391776"/>
        <c:axId val="193391216"/>
      </c:barChart>
      <c:valAx>
        <c:axId val="19339121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1776"/>
        <c:crosses val="autoZero"/>
        <c:crossBetween val="between"/>
      </c:valAx>
      <c:catAx>
        <c:axId val="1933917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121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1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9882666666666668</c:v>
                </c:pt>
                <c:pt idx="1">
                  <c:v>0.36676999999999998</c:v>
                </c:pt>
                <c:pt idx="2">
                  <c:v>0.33189000000000002</c:v>
                </c:pt>
                <c:pt idx="3">
                  <c:v>0.29906666666666665</c:v>
                </c:pt>
                <c:pt idx="4">
                  <c:v>0.29624999999999996</c:v>
                </c:pt>
                <c:pt idx="5">
                  <c:v>0.41118666666666664</c:v>
                </c:pt>
                <c:pt idx="6">
                  <c:v>0.57740000000000002</c:v>
                </c:pt>
                <c:pt idx="7">
                  <c:v>0.49889666666666671</c:v>
                </c:pt>
                <c:pt idx="8">
                  <c:v>0.37914000000000003</c:v>
                </c:pt>
                <c:pt idx="9">
                  <c:v>1.4536666666666668E-2</c:v>
                </c:pt>
                <c:pt idx="10">
                  <c:v>3.173666666666667E-2</c:v>
                </c:pt>
                <c:pt idx="11">
                  <c:v>0.11155333333333334</c:v>
                </c:pt>
                <c:pt idx="12">
                  <c:v>0.11036666666666667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8.1850000000000006E-2</c:v>
                </c:pt>
                <c:pt idx="1">
                  <c:v>0.1321</c:v>
                </c:pt>
                <c:pt idx="2">
                  <c:v>0.10937333333333332</c:v>
                </c:pt>
                <c:pt idx="3">
                  <c:v>0.18337666666666666</c:v>
                </c:pt>
                <c:pt idx="4">
                  <c:v>0.19019333333333333</c:v>
                </c:pt>
                <c:pt idx="5">
                  <c:v>0.12506666666666666</c:v>
                </c:pt>
                <c:pt idx="6">
                  <c:v>8.9619999999999991E-2</c:v>
                </c:pt>
                <c:pt idx="7">
                  <c:v>9.9366666666666659E-2</c:v>
                </c:pt>
                <c:pt idx="8">
                  <c:v>9.5163333333333336E-2</c:v>
                </c:pt>
                <c:pt idx="9">
                  <c:v>6.4933333333333336E-3</c:v>
                </c:pt>
                <c:pt idx="10">
                  <c:v>4.8850000000000005E-2</c:v>
                </c:pt>
                <c:pt idx="11">
                  <c:v>0.24689999999999998</c:v>
                </c:pt>
                <c:pt idx="12">
                  <c:v>7.1633333333333341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5244333333333328</c:v>
                </c:pt>
                <c:pt idx="1">
                  <c:v>0.28761333333333333</c:v>
                </c:pt>
                <c:pt idx="2">
                  <c:v>0.28209333333333331</c:v>
                </c:pt>
                <c:pt idx="3">
                  <c:v>0.19205333333333333</c:v>
                </c:pt>
                <c:pt idx="4">
                  <c:v>0.19188666666666668</c:v>
                </c:pt>
                <c:pt idx="5">
                  <c:v>0.19291666666666671</c:v>
                </c:pt>
                <c:pt idx="6">
                  <c:v>0.18717000000000003</c:v>
                </c:pt>
                <c:pt idx="7">
                  <c:v>0.18225333333333335</c:v>
                </c:pt>
                <c:pt idx="8">
                  <c:v>0.18083666666666665</c:v>
                </c:pt>
                <c:pt idx="9">
                  <c:v>0.44817333333333337</c:v>
                </c:pt>
                <c:pt idx="10">
                  <c:v>0.46879666666666669</c:v>
                </c:pt>
                <c:pt idx="11">
                  <c:v>0.38555333333333336</c:v>
                </c:pt>
                <c:pt idx="12">
                  <c:v>0.43477666666666664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6688000000000004</c:v>
                </c:pt>
                <c:pt idx="1">
                  <c:v>0.21351333333333333</c:v>
                </c:pt>
                <c:pt idx="2">
                  <c:v>0.27664000000000005</c:v>
                </c:pt>
                <c:pt idx="3">
                  <c:v>0.32550333333333337</c:v>
                </c:pt>
                <c:pt idx="4">
                  <c:v>0.32166666666666671</c:v>
                </c:pt>
                <c:pt idx="5">
                  <c:v>0.27082333333333336</c:v>
                </c:pt>
                <c:pt idx="6">
                  <c:v>0.14581333333333335</c:v>
                </c:pt>
                <c:pt idx="7">
                  <c:v>0.21948333333333334</c:v>
                </c:pt>
                <c:pt idx="8">
                  <c:v>0.34486333333333336</c:v>
                </c:pt>
                <c:pt idx="9">
                  <c:v>0.53080666666666676</c:v>
                </c:pt>
                <c:pt idx="10">
                  <c:v>0.45062000000000002</c:v>
                </c:pt>
                <c:pt idx="11">
                  <c:v>0.25599</c:v>
                </c:pt>
                <c:pt idx="12">
                  <c:v>0.3832266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677952"/>
        <c:axId val="193677392"/>
      </c:barChart>
      <c:valAx>
        <c:axId val="193677392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677952"/>
        <c:crosses val="autoZero"/>
        <c:crossBetween val="between"/>
      </c:valAx>
      <c:catAx>
        <c:axId val="1936779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67739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C4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5044</c:v>
                </c:pt>
                <c:pt idx="1">
                  <c:v>0.36365333333333333</c:v>
                </c:pt>
                <c:pt idx="2">
                  <c:v>0.33226</c:v>
                </c:pt>
                <c:pt idx="3">
                  <c:v>0.29440666666666665</c:v>
                </c:pt>
                <c:pt idx="4">
                  <c:v>0.30285666666666672</c:v>
                </c:pt>
                <c:pt idx="5">
                  <c:v>0.40619666666666659</c:v>
                </c:pt>
                <c:pt idx="6">
                  <c:v>0.56417666666666666</c:v>
                </c:pt>
                <c:pt idx="7">
                  <c:v>0.49491666666666667</c:v>
                </c:pt>
                <c:pt idx="8">
                  <c:v>0.38714333333333334</c:v>
                </c:pt>
                <c:pt idx="9">
                  <c:v>1.7806666666666665E-2</c:v>
                </c:pt>
                <c:pt idx="10">
                  <c:v>4.0779999999999997E-2</c:v>
                </c:pt>
                <c:pt idx="11">
                  <c:v>0.14649333333333334</c:v>
                </c:pt>
                <c:pt idx="12">
                  <c:v>0.13734333333333335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0.10541333333333334</c:v>
                </c:pt>
                <c:pt idx="1">
                  <c:v>0.14398333333333332</c:v>
                </c:pt>
                <c:pt idx="2">
                  <c:v>0.12318</c:v>
                </c:pt>
                <c:pt idx="3">
                  <c:v>0.18562666666666669</c:v>
                </c:pt>
                <c:pt idx="4">
                  <c:v>0.19299999999999998</c:v>
                </c:pt>
                <c:pt idx="5">
                  <c:v>0.13034666666666667</c:v>
                </c:pt>
                <c:pt idx="6">
                  <c:v>9.5123333333333338E-2</c:v>
                </c:pt>
                <c:pt idx="7">
                  <c:v>0.10167666666666665</c:v>
                </c:pt>
                <c:pt idx="8">
                  <c:v>9.0090000000000003E-2</c:v>
                </c:pt>
                <c:pt idx="9">
                  <c:v>7.6733333333333332E-3</c:v>
                </c:pt>
                <c:pt idx="10">
                  <c:v>8.5000000000000006E-2</c:v>
                </c:pt>
                <c:pt idx="11">
                  <c:v>0.22221000000000002</c:v>
                </c:pt>
                <c:pt idx="12">
                  <c:v>8.3376666666666654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1965333333333334</c:v>
                </c:pt>
                <c:pt idx="1">
                  <c:v>0.26880999999999999</c:v>
                </c:pt>
                <c:pt idx="2">
                  <c:v>0.26389333333333331</c:v>
                </c:pt>
                <c:pt idx="3">
                  <c:v>0.19447666666666666</c:v>
                </c:pt>
                <c:pt idx="4">
                  <c:v>0.18798666666666666</c:v>
                </c:pt>
                <c:pt idx="5">
                  <c:v>0.19042666666666666</c:v>
                </c:pt>
                <c:pt idx="6">
                  <c:v>0.19442333333333331</c:v>
                </c:pt>
                <c:pt idx="7">
                  <c:v>0.19142333333333336</c:v>
                </c:pt>
                <c:pt idx="8">
                  <c:v>0.21025333333333332</c:v>
                </c:pt>
                <c:pt idx="9">
                  <c:v>0.45402666666666663</c:v>
                </c:pt>
                <c:pt idx="10">
                  <c:v>0.46240666666666669</c:v>
                </c:pt>
                <c:pt idx="11">
                  <c:v>0.37658333333333333</c:v>
                </c:pt>
                <c:pt idx="12">
                  <c:v>0.42555333333333339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2449</c:v>
                </c:pt>
                <c:pt idx="1">
                  <c:v>0.22355666666666665</c:v>
                </c:pt>
                <c:pt idx="2">
                  <c:v>0.28066333333333332</c:v>
                </c:pt>
                <c:pt idx="3">
                  <c:v>0.32548666666666665</c:v>
                </c:pt>
                <c:pt idx="4">
                  <c:v>0.31615333333333334</c:v>
                </c:pt>
                <c:pt idx="5">
                  <c:v>0.27303333333333329</c:v>
                </c:pt>
                <c:pt idx="6">
                  <c:v>0.14627666666666669</c:v>
                </c:pt>
                <c:pt idx="7">
                  <c:v>0.21198333333333333</c:v>
                </c:pt>
                <c:pt idx="8">
                  <c:v>0.31251000000000001</c:v>
                </c:pt>
                <c:pt idx="9">
                  <c:v>0.52049333333333336</c:v>
                </c:pt>
                <c:pt idx="10">
                  <c:v>0.41181000000000001</c:v>
                </c:pt>
                <c:pt idx="11">
                  <c:v>0.25471333333333335</c:v>
                </c:pt>
                <c:pt idx="12">
                  <c:v>0.3537266666666666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398496"/>
        <c:axId val="193397936"/>
      </c:barChart>
      <c:valAx>
        <c:axId val="19339793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8496"/>
        <c:crosses val="autoZero"/>
        <c:crossBetween val="between"/>
      </c:valAx>
      <c:catAx>
        <c:axId val="1933984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39793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QT4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23406666666666665</c:v>
                </c:pt>
                <c:pt idx="1">
                  <c:v>0.36203000000000002</c:v>
                </c:pt>
                <c:pt idx="2">
                  <c:v>0.33896666666666664</c:v>
                </c:pt>
                <c:pt idx="3">
                  <c:v>0.30487333333333333</c:v>
                </c:pt>
                <c:pt idx="4">
                  <c:v>0.30929333333333336</c:v>
                </c:pt>
                <c:pt idx="5">
                  <c:v>0.41416999999999998</c:v>
                </c:pt>
                <c:pt idx="6">
                  <c:v>0.57106333333333337</c:v>
                </c:pt>
                <c:pt idx="7">
                  <c:v>0.50189666666666666</c:v>
                </c:pt>
                <c:pt idx="8">
                  <c:v>0.40326000000000001</c:v>
                </c:pt>
                <c:pt idx="9">
                  <c:v>1.8610000000000002E-2</c:v>
                </c:pt>
                <c:pt idx="10">
                  <c:v>4.7059999999999998E-2</c:v>
                </c:pt>
                <c:pt idx="11">
                  <c:v>0.15553666666666668</c:v>
                </c:pt>
                <c:pt idx="12">
                  <c:v>0.15196666666666667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9.5386666666666675E-2</c:v>
                </c:pt>
                <c:pt idx="1">
                  <c:v>0.14222333333333334</c:v>
                </c:pt>
                <c:pt idx="2">
                  <c:v>0.12145333333333334</c:v>
                </c:pt>
                <c:pt idx="3">
                  <c:v>0.19816333333333333</c:v>
                </c:pt>
                <c:pt idx="4">
                  <c:v>0.19054666666666664</c:v>
                </c:pt>
                <c:pt idx="5">
                  <c:v>0.12861666666666668</c:v>
                </c:pt>
                <c:pt idx="6">
                  <c:v>9.2296666666666652E-2</c:v>
                </c:pt>
                <c:pt idx="7">
                  <c:v>9.9470000000000003E-2</c:v>
                </c:pt>
                <c:pt idx="8">
                  <c:v>8.5383333333333325E-2</c:v>
                </c:pt>
                <c:pt idx="9">
                  <c:v>7.5100000000000002E-3</c:v>
                </c:pt>
                <c:pt idx="10">
                  <c:v>4.9680000000000002E-2</c:v>
                </c:pt>
                <c:pt idx="11">
                  <c:v>0.18393999999999999</c:v>
                </c:pt>
                <c:pt idx="12">
                  <c:v>8.4860000000000005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3472999999999997</c:v>
                </c:pt>
                <c:pt idx="1">
                  <c:v>0.27506333333333333</c:v>
                </c:pt>
                <c:pt idx="2">
                  <c:v>0.26512333333333332</c:v>
                </c:pt>
                <c:pt idx="3">
                  <c:v>0.18666000000000002</c:v>
                </c:pt>
                <c:pt idx="4">
                  <c:v>0.18633</c:v>
                </c:pt>
                <c:pt idx="5">
                  <c:v>0.18782666666666667</c:v>
                </c:pt>
                <c:pt idx="6">
                  <c:v>0.19184999999999999</c:v>
                </c:pt>
                <c:pt idx="7">
                  <c:v>0.18954666666666667</c:v>
                </c:pt>
                <c:pt idx="8">
                  <c:v>0.20685666666666669</c:v>
                </c:pt>
                <c:pt idx="9">
                  <c:v>0.4486033333333333</c:v>
                </c:pt>
                <c:pt idx="10">
                  <c:v>0.46500000000000002</c:v>
                </c:pt>
                <c:pt idx="11">
                  <c:v>0.3676733333333333</c:v>
                </c:pt>
                <c:pt idx="12">
                  <c:v>0.41672999999999999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358133333333333</c:v>
                </c:pt>
                <c:pt idx="1">
                  <c:v>0.22067999999999999</c:v>
                </c:pt>
                <c:pt idx="2">
                  <c:v>0.27445666666666663</c:v>
                </c:pt>
                <c:pt idx="3">
                  <c:v>0.31030333333333332</c:v>
                </c:pt>
                <c:pt idx="4">
                  <c:v>0.31383</c:v>
                </c:pt>
                <c:pt idx="5">
                  <c:v>0.26938666666666666</c:v>
                </c:pt>
                <c:pt idx="6">
                  <c:v>0.14479</c:v>
                </c:pt>
                <c:pt idx="7">
                  <c:v>0.20908000000000002</c:v>
                </c:pt>
                <c:pt idx="8">
                  <c:v>0.30449999999999999</c:v>
                </c:pt>
                <c:pt idx="9">
                  <c:v>0.52527666666666673</c:v>
                </c:pt>
                <c:pt idx="10">
                  <c:v>0.43826333333333328</c:v>
                </c:pt>
                <c:pt idx="11">
                  <c:v>0.29285666666666665</c:v>
                </c:pt>
                <c:pt idx="12">
                  <c:v>0.34644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241889376"/>
        <c:axId val="241889936"/>
      </c:barChart>
      <c:valAx>
        <c:axId val="24188993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89376"/>
        <c:crosses val="autoZero"/>
        <c:crossBetween val="between"/>
      </c:valAx>
      <c:catAx>
        <c:axId val="2418893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4188993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RC1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B$2:$B$14</c:f>
              <c:numCache>
                <c:formatCode>General</c:formatCode>
                <c:ptCount val="13"/>
                <c:pt idx="0">
                  <c:v>0.18350666666666668</c:v>
                </c:pt>
                <c:pt idx="1">
                  <c:v>0.36743999999999999</c:v>
                </c:pt>
                <c:pt idx="2">
                  <c:v>0.34324333333333334</c:v>
                </c:pt>
                <c:pt idx="3">
                  <c:v>0.2991833333333333</c:v>
                </c:pt>
                <c:pt idx="4">
                  <c:v>0.3004</c:v>
                </c:pt>
                <c:pt idx="5">
                  <c:v>0.40981666666666666</c:v>
                </c:pt>
                <c:pt idx="6">
                  <c:v>0.5676066666666667</c:v>
                </c:pt>
                <c:pt idx="7">
                  <c:v>0.49537999999999999</c:v>
                </c:pt>
                <c:pt idx="8">
                  <c:v>0.40996666666666665</c:v>
                </c:pt>
                <c:pt idx="9">
                  <c:v>1.8030000000000001E-2</c:v>
                </c:pt>
                <c:pt idx="10">
                  <c:v>4.3546666666666671E-2</c:v>
                </c:pt>
                <c:pt idx="11">
                  <c:v>0.11795333333333334</c:v>
                </c:pt>
                <c:pt idx="12">
                  <c:v>0.12178666666666667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C$2:$C$14</c:f>
              <c:numCache>
                <c:formatCode>General</c:formatCode>
                <c:ptCount val="13"/>
                <c:pt idx="0">
                  <c:v>7.7293333333333325E-2</c:v>
                </c:pt>
                <c:pt idx="1">
                  <c:v>0.13618666666666668</c:v>
                </c:pt>
                <c:pt idx="2">
                  <c:v>0.11733333333333333</c:v>
                </c:pt>
                <c:pt idx="3">
                  <c:v>0.18958</c:v>
                </c:pt>
                <c:pt idx="4">
                  <c:v>0.19366666666666668</c:v>
                </c:pt>
                <c:pt idx="5">
                  <c:v>0.12926000000000001</c:v>
                </c:pt>
                <c:pt idx="6">
                  <c:v>9.4223333333333326E-2</c:v>
                </c:pt>
                <c:pt idx="7">
                  <c:v>0.10133333333333333</c:v>
                </c:pt>
                <c:pt idx="8">
                  <c:v>9.0899999999999995E-2</c:v>
                </c:pt>
                <c:pt idx="9">
                  <c:v>7.9366666666666665E-3</c:v>
                </c:pt>
                <c:pt idx="10">
                  <c:v>4.9229999999999996E-2</c:v>
                </c:pt>
                <c:pt idx="11">
                  <c:v>0.26048333333333334</c:v>
                </c:pt>
                <c:pt idx="12">
                  <c:v>7.2429999999999994E-2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G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D$2:$D$14</c:f>
              <c:numCache>
                <c:formatCode>General</c:formatCode>
                <c:ptCount val="13"/>
                <c:pt idx="0">
                  <c:v>0.36927666666666664</c:v>
                </c:pt>
                <c:pt idx="1">
                  <c:v>0.29522000000000004</c:v>
                </c:pt>
                <c:pt idx="2">
                  <c:v>0.27991666666666665</c:v>
                </c:pt>
                <c:pt idx="3">
                  <c:v>0.19643333333333332</c:v>
                </c:pt>
                <c:pt idx="4">
                  <c:v>0.18642</c:v>
                </c:pt>
                <c:pt idx="5">
                  <c:v>0.19666333333333333</c:v>
                </c:pt>
                <c:pt idx="6">
                  <c:v>0.19094</c:v>
                </c:pt>
                <c:pt idx="7">
                  <c:v>0.18804333333333334</c:v>
                </c:pt>
                <c:pt idx="8">
                  <c:v>0.17726666666666668</c:v>
                </c:pt>
                <c:pt idx="9">
                  <c:v>0.44851000000000002</c:v>
                </c:pt>
                <c:pt idx="10">
                  <c:v>0.45927000000000001</c:v>
                </c:pt>
                <c:pt idx="11">
                  <c:v>0.38384333333333331</c:v>
                </c:pt>
                <c:pt idx="12">
                  <c:v>0.42135999999999996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U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numRef>
              <c:f>Sheet1!$A$2:$A$14</c:f>
              <c:numCache>
                <c:formatCode>General</c:formatCode>
                <c:ptCount val="13"/>
                <c:pt idx="0">
                  <c:v>18</c:v>
                </c:pt>
                <c:pt idx="1">
                  <c:v>19</c:v>
                </c:pt>
                <c:pt idx="2">
                  <c:v>20</c:v>
                </c:pt>
                <c:pt idx="3">
                  <c:v>21</c:v>
                </c:pt>
                <c:pt idx="4">
                  <c:v>22</c:v>
                </c:pt>
                <c:pt idx="5">
                  <c:v>23</c:v>
                </c:pt>
                <c:pt idx="6">
                  <c:v>24</c:v>
                </c:pt>
                <c:pt idx="7">
                  <c:v>25</c:v>
                </c:pt>
                <c:pt idx="8">
                  <c:v>26</c:v>
                </c:pt>
                <c:pt idx="9">
                  <c:v>27</c:v>
                </c:pt>
                <c:pt idx="10">
                  <c:v>28</c:v>
                </c:pt>
                <c:pt idx="11">
                  <c:v>29</c:v>
                </c:pt>
                <c:pt idx="12">
                  <c:v>30</c:v>
                </c:pt>
              </c:numCache>
            </c:numRef>
          </c:cat>
          <c:val>
            <c:numRef>
              <c:f>Sheet1!$E$2:$E$14</c:f>
              <c:numCache>
                <c:formatCode>General</c:formatCode>
                <c:ptCount val="13"/>
                <c:pt idx="0">
                  <c:v>0.36992666666666668</c:v>
                </c:pt>
                <c:pt idx="1">
                  <c:v>0.20114666666666667</c:v>
                </c:pt>
                <c:pt idx="2">
                  <c:v>0.25950333333333336</c:v>
                </c:pt>
                <c:pt idx="3">
                  <c:v>0.31480333333333332</c:v>
                </c:pt>
                <c:pt idx="4">
                  <c:v>0.31951000000000002</c:v>
                </c:pt>
                <c:pt idx="5">
                  <c:v>0.2642566666666667</c:v>
                </c:pt>
                <c:pt idx="6">
                  <c:v>0.14723</c:v>
                </c:pt>
                <c:pt idx="7">
                  <c:v>0.21524333333333331</c:v>
                </c:pt>
                <c:pt idx="8">
                  <c:v>0.32186666666666669</c:v>
                </c:pt>
                <c:pt idx="9">
                  <c:v>0.52552999999999994</c:v>
                </c:pt>
                <c:pt idx="10">
                  <c:v>0.44794666666666666</c:v>
                </c:pt>
                <c:pt idx="11">
                  <c:v>0.23772000000000001</c:v>
                </c:pt>
                <c:pt idx="12">
                  <c:v>0.384423333333333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44"/>
        <c:overlap val="-90"/>
        <c:axId val="193402976"/>
        <c:axId val="193402416"/>
      </c:barChart>
      <c:valAx>
        <c:axId val="193402416"/>
        <c:scaling>
          <c:orientation val="minMax"/>
          <c:max val="1"/>
        </c:scaling>
        <c:delete val="0"/>
        <c:axPos val="l"/>
        <c:numFmt formatCode="0%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402976"/>
        <c:crosses val="autoZero"/>
        <c:crossBetween val="between"/>
      </c:valAx>
      <c:catAx>
        <c:axId val="19340297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9340241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1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2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0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064" b="0" i="0" u="none" strike="noStrike" kern="1200" baseline="0"/>
    <cs:bodyPr rot="-5400000" spcFirstLastPara="1" vertOverflow="clip" horzOverflow="clip" vert="horz" wrap="square" lIns="38100" tIns="19050" rIns="38100" bIns="19050" anchor="ctr" anchorCtr="1">
      <a:spAutoFit/>
    </cs:bodyPr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67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46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569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796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3540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598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847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8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068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968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633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05AB86-0210-4417-A998-E82F52DEBB13}" type="datetimeFigureOut">
              <a:rPr lang="en-US" smtClean="0"/>
              <a:t>3/2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B7A95-DDB0-4B58-8FB5-241947BC1D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021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43755588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1729388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47278290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63211462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06026741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909583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61686280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6116454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97418233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07868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27256278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944619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1350324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707692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81295445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350826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09733136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283580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83400886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048832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30691210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683461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85414523"/>
              </p:ext>
            </p:extLst>
          </p:nvPr>
        </p:nvGraphicFramePr>
        <p:xfrm>
          <a:off x="838200" y="519113"/>
          <a:ext cx="10515600" cy="5657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830378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28</Words>
  <Application>Microsoft Office PowerPoint</Application>
  <PresentationFormat>Widescreen</PresentationFormat>
  <Paragraphs>16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S</dc:creator>
  <cp:lastModifiedBy>NS</cp:lastModifiedBy>
  <cp:revision>24</cp:revision>
  <dcterms:created xsi:type="dcterms:W3CDTF">2019-03-23T18:15:24Z</dcterms:created>
  <dcterms:modified xsi:type="dcterms:W3CDTF">2019-03-25T02:15:33Z</dcterms:modified>
</cp:coreProperties>
</file>